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12192000" cy="121681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47" d="100"/>
          <a:sy n="47" d="100"/>
        </p:scale>
        <p:origin x="175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991415"/>
            <a:ext cx="10363200" cy="423633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391116"/>
            <a:ext cx="9144000" cy="293782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092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7781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47843"/>
            <a:ext cx="2628900" cy="103119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47843"/>
            <a:ext cx="7734300" cy="103119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9131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8378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033601"/>
            <a:ext cx="10515600" cy="5061627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8143113"/>
            <a:ext cx="10515600" cy="2661790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2370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239216"/>
            <a:ext cx="5181600" cy="772060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239216"/>
            <a:ext cx="5181600" cy="772060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9679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47846"/>
            <a:ext cx="10515600" cy="2351954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982897"/>
            <a:ext cx="5157787" cy="146187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444769"/>
            <a:ext cx="5157787" cy="653758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982897"/>
            <a:ext cx="5183188" cy="146187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444769"/>
            <a:ext cx="5183188" cy="653758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507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3275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0534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11212"/>
            <a:ext cx="3932237" cy="2839244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751997"/>
            <a:ext cx="6172200" cy="864730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650456"/>
            <a:ext cx="3932237" cy="6762922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7828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11212"/>
            <a:ext cx="3932237" cy="2839244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751997"/>
            <a:ext cx="6172200" cy="864730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650456"/>
            <a:ext cx="3932237" cy="6762922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6186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47846"/>
            <a:ext cx="10515600" cy="23519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239216"/>
            <a:ext cx="10515600" cy="77206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1278110"/>
            <a:ext cx="2743200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498DC2-1AFC-453F-9625-6A12DCA95A79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1278110"/>
            <a:ext cx="4114800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1278110"/>
            <a:ext cx="2743200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329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Grafik 7">
            <a:extLst>
              <a:ext uri="{FF2B5EF4-FFF2-40B4-BE49-F238E27FC236}">
                <a16:creationId xmlns:a16="http://schemas.microsoft.com/office/drawing/2014/main" id="{4053EF77-640F-4DFA-B7DA-1852AE1DD6F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70"/>
          <a:stretch/>
        </p:blipFill>
        <p:spPr>
          <a:xfrm>
            <a:off x="244117" y="666786"/>
            <a:ext cx="11703765" cy="5417308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D9A38C3B-54EE-4175-9749-D2B8F50C1AF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70"/>
          <a:stretch/>
        </p:blipFill>
        <p:spPr>
          <a:xfrm>
            <a:off x="244117" y="6515100"/>
            <a:ext cx="11703765" cy="5417308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D50B47E9-C0F2-4752-9D94-D6E4B2E4D7C5}"/>
              </a:ext>
            </a:extLst>
          </p:cNvPr>
          <p:cNvSpPr txBox="1"/>
          <p:nvPr/>
        </p:nvSpPr>
        <p:spPr>
          <a:xfrm>
            <a:off x="244117" y="229516"/>
            <a:ext cx="86051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(A)		</a:t>
            </a:r>
            <a:r>
              <a:rPr lang="en-GB" sz="2400" dirty="0"/>
              <a:t>GO enriched biological processes in module lightpink4</a:t>
            </a:r>
          </a:p>
          <a:p>
            <a:r>
              <a:rPr lang="en-GB" sz="2400" b="1" dirty="0"/>
              <a:t> 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879381F4-C0F0-466A-B645-70CC9F64BBB1}"/>
              </a:ext>
            </a:extLst>
          </p:cNvPr>
          <p:cNvSpPr txBox="1"/>
          <p:nvPr/>
        </p:nvSpPr>
        <p:spPr>
          <a:xfrm>
            <a:off x="244117" y="6099601"/>
            <a:ext cx="919298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/>
              <a:t>(B)</a:t>
            </a:r>
            <a:r>
              <a:rPr lang="en-GB" sz="2400" b="1" dirty="0"/>
              <a:t>		</a:t>
            </a:r>
            <a:r>
              <a:rPr lang="en-GB" sz="2400" dirty="0"/>
              <a:t>GO enriched biological processes in module </a:t>
            </a:r>
            <a:r>
              <a:rPr lang="en-GB" sz="2400" dirty="0" err="1"/>
              <a:t>midnightblue</a:t>
            </a:r>
            <a:endParaRPr lang="en-GB" sz="2400" dirty="0"/>
          </a:p>
          <a:p>
            <a:r>
              <a:rPr lang="en-GB" sz="2400" b="1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345645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</Words>
  <Application>Microsoft Office PowerPoint</Application>
  <PresentationFormat>Benutzerdefiniert</PresentationFormat>
  <Paragraphs>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ritsch Silvia</dc:creator>
  <cp:lastModifiedBy>Madritsch Silvia</cp:lastModifiedBy>
  <cp:revision>6</cp:revision>
  <dcterms:created xsi:type="dcterms:W3CDTF">2020-02-20T12:10:15Z</dcterms:created>
  <dcterms:modified xsi:type="dcterms:W3CDTF">2020-02-24T09:03:20Z</dcterms:modified>
</cp:coreProperties>
</file>